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241"/>
    <p:restoredTop sz="96327"/>
  </p:normalViewPr>
  <p:slideViewPr>
    <p:cSldViewPr snapToGrid="0">
      <p:cViewPr varScale="1">
        <p:scale>
          <a:sx n="105" d="100"/>
          <a:sy n="105" d="100"/>
        </p:scale>
        <p:origin x="208" y="6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75B602-1803-7E72-671E-1A0639E983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B783CD9-63C3-C65E-1A7B-6260FF0092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75ED0EF-6A58-FF02-2017-7BEFD6D43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2E1AE43-CD32-BAEE-EC70-4DD6FAD3B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0A57F43-9793-ACF0-AF99-C9250C9C5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3704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0172D9-F207-3E29-3319-0D6F3FE41B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7489FAF-E292-3765-D0D0-12D4E90EB8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4285AB-7545-21A7-02BA-087C118DE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314375-1BEA-22E3-3708-7B80CEA15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F5135F-7E39-83AD-77C6-CE0111F78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1833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EE2D4DB-A0B5-2796-03D5-D0F3CBD1BC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51AF6C2-1922-6C89-6EF8-101EF5B3E4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85C194-0343-B8D5-7A76-DB93569BC0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A379270-FC5E-7B0B-D657-71DF19EAD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D009CF7-EB08-305A-3B37-839AE9516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822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FAEF9E-A2E9-3267-9FB2-15B613B606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C865AA1-7B07-60A4-FFA5-E7B3EFF061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F25D07-9A3F-312B-1D44-F9E981E4A1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9064B5A-DB90-FFB9-36FF-664508B48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D18F350-0D11-B68D-0982-7AFD7C5DE2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0443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0D9A8E-89CF-2B44-B405-B5885F47A5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F1CAE08-5A41-B03C-C240-3EFF8AF3F5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72F8AC-DD99-2678-95A2-1D0646521B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EBA8AB-75A6-8AF4-2146-0AAF98FDC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329A1B-4ECC-638E-B91A-398147032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1446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958C42-CF95-A57B-248E-941B58FE63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8B78952-903F-DCA3-43DA-C47E3C6D54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D0B58E3-64FF-BBBA-24A7-558C202FA8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C117D44-BDCD-1D72-A9F7-821B114A1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A14F65D-0885-ADE5-4A23-854946290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F065E90-6B29-AB59-2059-3FAF8F061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4170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9AE425-B4EF-0743-56A3-63FA063635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CF9D8E0-D0F8-1F26-E85D-B7E0FA1FA5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EF26E6F-B8FE-113B-1FE0-6847A918D6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CCB9307-AEBF-3A4E-8685-7620B7AEEC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AF056D4-1CAA-FED7-255F-76834D393F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809D5C5-4230-4120-6072-E4B3D6A92A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18AE42F-252C-B928-0B90-087CD31154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F7B6259-8539-0B5F-E466-CD8A5BA00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325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0A23784-3D37-B673-ACC5-428DA81349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CD759C8-238B-C86B-3CE7-3BFCD884E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3F63574-E150-C6C6-6701-EA25893FD6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DDB675E-3F16-6AB7-36D1-0314D83F02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351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8CF90DA-3E6C-4D60-AE6C-04A9FDA921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80CA0E8-CD97-0979-29F7-63BD868C4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7E64D87-8510-DD59-0E92-4F167D383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3510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7C75E0-ACD8-BE8F-4947-5C335E26B0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5C209ED-629A-AD45-37BF-2EC8A6E2B1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ED81A51-B6CD-430E-B480-F67BF77E44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C6E9CD7-2555-70D2-2073-274AB755C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7AC6020-659D-BC65-D02D-2B39A3E63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364AF30-3FAB-6905-348A-98E4DA07A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273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99C5B4-4F88-69F1-CEA0-A9A0FD7CC9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59A4CE7-713F-336D-4F5A-E8807424D3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B0997CE-9294-7C61-B530-A192F7C0C4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969894-1459-3793-6D58-F7CC4EE22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ADA2AF1-734E-D239-24D7-BE20AB5AF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FC14130-5AF2-203C-F924-A36072AC42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357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A4AAC59-210F-183A-0F8C-280E4F72FB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2545EAA-004D-7B0B-30FF-AEF49FD67A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69C5FB-2A4F-6FF7-69D3-6259B42ACA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A8A089-0A9A-A94C-A0B7-31886DB65FDC}" type="datetimeFigureOut">
              <a:rPr kumimoji="1" lang="ja-JP" altLang="en-US" smtClean="0"/>
              <a:t>2024/1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C8F758C-BBCB-1CB2-AA25-7DA74306E8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25435A4-7B70-7FAE-D312-36933E4BF7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38E76-A250-964C-96CC-9EACC2EF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565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0" name="表 39">
            <a:extLst>
              <a:ext uri="{FF2B5EF4-FFF2-40B4-BE49-F238E27FC236}">
                <a16:creationId xmlns:a16="http://schemas.microsoft.com/office/drawing/2014/main" id="{59BF40A6-C015-CA54-8488-AEED2A5BF9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8027682"/>
              </p:ext>
            </p:extLst>
          </p:nvPr>
        </p:nvGraphicFramePr>
        <p:xfrm>
          <a:off x="573025" y="271780"/>
          <a:ext cx="5681476" cy="21209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27348">
                  <a:extLst>
                    <a:ext uri="{9D8B030D-6E8A-4147-A177-3AD203B41FA5}">
                      <a16:colId xmlns:a16="http://schemas.microsoft.com/office/drawing/2014/main" val="1545891460"/>
                    </a:ext>
                  </a:extLst>
                </a:gridCol>
                <a:gridCol w="506591">
                  <a:extLst>
                    <a:ext uri="{9D8B030D-6E8A-4147-A177-3AD203B41FA5}">
                      <a16:colId xmlns:a16="http://schemas.microsoft.com/office/drawing/2014/main" val="2339621632"/>
                    </a:ext>
                  </a:extLst>
                </a:gridCol>
                <a:gridCol w="506591">
                  <a:extLst>
                    <a:ext uri="{9D8B030D-6E8A-4147-A177-3AD203B41FA5}">
                      <a16:colId xmlns:a16="http://schemas.microsoft.com/office/drawing/2014/main" val="2537923341"/>
                    </a:ext>
                  </a:extLst>
                </a:gridCol>
                <a:gridCol w="577278">
                  <a:extLst>
                    <a:ext uri="{9D8B030D-6E8A-4147-A177-3AD203B41FA5}">
                      <a16:colId xmlns:a16="http://schemas.microsoft.com/office/drawing/2014/main" val="30637217"/>
                    </a:ext>
                  </a:extLst>
                </a:gridCol>
                <a:gridCol w="577278">
                  <a:extLst>
                    <a:ext uri="{9D8B030D-6E8A-4147-A177-3AD203B41FA5}">
                      <a16:colId xmlns:a16="http://schemas.microsoft.com/office/drawing/2014/main" val="3985117786"/>
                    </a:ext>
                  </a:extLst>
                </a:gridCol>
                <a:gridCol w="577278">
                  <a:extLst>
                    <a:ext uri="{9D8B030D-6E8A-4147-A177-3AD203B41FA5}">
                      <a16:colId xmlns:a16="http://schemas.microsoft.com/office/drawing/2014/main" val="203316825"/>
                    </a:ext>
                  </a:extLst>
                </a:gridCol>
                <a:gridCol w="577278">
                  <a:extLst>
                    <a:ext uri="{9D8B030D-6E8A-4147-A177-3AD203B41FA5}">
                      <a16:colId xmlns:a16="http://schemas.microsoft.com/office/drawing/2014/main" val="1543650430"/>
                    </a:ext>
                  </a:extLst>
                </a:gridCol>
                <a:gridCol w="577278">
                  <a:extLst>
                    <a:ext uri="{9D8B030D-6E8A-4147-A177-3AD203B41FA5}">
                      <a16:colId xmlns:a16="http://schemas.microsoft.com/office/drawing/2014/main" val="3139723225"/>
                    </a:ext>
                  </a:extLst>
                </a:gridCol>
                <a:gridCol w="577278">
                  <a:extLst>
                    <a:ext uri="{9D8B030D-6E8A-4147-A177-3AD203B41FA5}">
                      <a16:colId xmlns:a16="http://schemas.microsoft.com/office/drawing/2014/main" val="2501352345"/>
                    </a:ext>
                  </a:extLst>
                </a:gridCol>
                <a:gridCol w="577278">
                  <a:extLst>
                    <a:ext uri="{9D8B030D-6E8A-4147-A177-3AD203B41FA5}">
                      <a16:colId xmlns:a16="http://schemas.microsoft.com/office/drawing/2014/main" val="455922501"/>
                    </a:ext>
                  </a:extLst>
                </a:gridCol>
              </a:tblGrid>
              <a:tr h="179231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PubMed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238306476"/>
                  </a:ext>
                </a:extLst>
              </a:tr>
              <a:tr h="1792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1737939"/>
                  </a:ext>
                </a:extLst>
              </a:tr>
              <a:tr h="78911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 dirty="0">
                          <a:effectLst/>
                        </a:rPr>
                        <a:t>((glucocorticoid-induced[TIAB] OR "steroid-induced"[TIAB]) AND (osteoporosis[TIAB] OR fracture[TIAB])) OR GIOP[TIAB] AND (("2000/1/1"[CRDT] : "3000"[CRDT]))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,41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4976188"/>
                  </a:ext>
                </a:extLst>
              </a:tr>
              <a:tr h="7940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"Vitamin D"[TIAB] OR Alfacalcidol[TIAB] OR Calcitriol[TIAB] OR Eldecalcitol[TIAB])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59,719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9100281"/>
                  </a:ext>
                </a:extLst>
              </a:tr>
              <a:tr h="1792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245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95036159"/>
                  </a:ext>
                </a:extLst>
              </a:tr>
            </a:tbl>
          </a:graphicData>
        </a:graphic>
      </p:graphicFrame>
      <p:graphicFrame>
        <p:nvGraphicFramePr>
          <p:cNvPr id="41" name="表 40">
            <a:extLst>
              <a:ext uri="{FF2B5EF4-FFF2-40B4-BE49-F238E27FC236}">
                <a16:creationId xmlns:a16="http://schemas.microsoft.com/office/drawing/2014/main" id="{C4412884-176D-360C-2B43-83AF027CEF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6524976"/>
              </p:ext>
            </p:extLst>
          </p:nvPr>
        </p:nvGraphicFramePr>
        <p:xfrm>
          <a:off x="591820" y="2474976"/>
          <a:ext cx="5650487" cy="387843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24250">
                  <a:extLst>
                    <a:ext uri="{9D8B030D-6E8A-4147-A177-3AD203B41FA5}">
                      <a16:colId xmlns:a16="http://schemas.microsoft.com/office/drawing/2014/main" val="3248923356"/>
                    </a:ext>
                  </a:extLst>
                </a:gridCol>
                <a:gridCol w="501159">
                  <a:extLst>
                    <a:ext uri="{9D8B030D-6E8A-4147-A177-3AD203B41FA5}">
                      <a16:colId xmlns:a16="http://schemas.microsoft.com/office/drawing/2014/main" val="3141397823"/>
                    </a:ext>
                  </a:extLst>
                </a:gridCol>
                <a:gridCol w="504089">
                  <a:extLst>
                    <a:ext uri="{9D8B030D-6E8A-4147-A177-3AD203B41FA5}">
                      <a16:colId xmlns:a16="http://schemas.microsoft.com/office/drawing/2014/main" val="4255185602"/>
                    </a:ext>
                  </a:extLst>
                </a:gridCol>
                <a:gridCol w="574427">
                  <a:extLst>
                    <a:ext uri="{9D8B030D-6E8A-4147-A177-3AD203B41FA5}">
                      <a16:colId xmlns:a16="http://schemas.microsoft.com/office/drawing/2014/main" val="1119143413"/>
                    </a:ext>
                  </a:extLst>
                </a:gridCol>
                <a:gridCol w="574427">
                  <a:extLst>
                    <a:ext uri="{9D8B030D-6E8A-4147-A177-3AD203B41FA5}">
                      <a16:colId xmlns:a16="http://schemas.microsoft.com/office/drawing/2014/main" val="4233355557"/>
                    </a:ext>
                  </a:extLst>
                </a:gridCol>
                <a:gridCol w="574427">
                  <a:extLst>
                    <a:ext uri="{9D8B030D-6E8A-4147-A177-3AD203B41FA5}">
                      <a16:colId xmlns:a16="http://schemas.microsoft.com/office/drawing/2014/main" val="1558426827"/>
                    </a:ext>
                  </a:extLst>
                </a:gridCol>
                <a:gridCol w="574427">
                  <a:extLst>
                    <a:ext uri="{9D8B030D-6E8A-4147-A177-3AD203B41FA5}">
                      <a16:colId xmlns:a16="http://schemas.microsoft.com/office/drawing/2014/main" val="355982620"/>
                    </a:ext>
                  </a:extLst>
                </a:gridCol>
                <a:gridCol w="574427">
                  <a:extLst>
                    <a:ext uri="{9D8B030D-6E8A-4147-A177-3AD203B41FA5}">
                      <a16:colId xmlns:a16="http://schemas.microsoft.com/office/drawing/2014/main" val="4174467781"/>
                    </a:ext>
                  </a:extLst>
                </a:gridCol>
                <a:gridCol w="574427">
                  <a:extLst>
                    <a:ext uri="{9D8B030D-6E8A-4147-A177-3AD203B41FA5}">
                      <a16:colId xmlns:a16="http://schemas.microsoft.com/office/drawing/2014/main" val="701855628"/>
                    </a:ext>
                  </a:extLst>
                </a:gridCol>
                <a:gridCol w="574427">
                  <a:extLst>
                    <a:ext uri="{9D8B030D-6E8A-4147-A177-3AD203B41FA5}">
                      <a16:colId xmlns:a16="http://schemas.microsoft.com/office/drawing/2014/main" val="855248222"/>
                    </a:ext>
                  </a:extLst>
                </a:gridCol>
              </a:tblGrid>
              <a:tr h="20182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Scopus (Embase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94227266"/>
                  </a:ext>
                </a:extLst>
              </a:tr>
              <a:tr h="20182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8182059"/>
                  </a:ext>
                </a:extLst>
              </a:tr>
              <a:tr h="168748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 TITLE-ABS ( osteoporosis )  OR  TITLE-ABS ( fracture ) )  AND  ( TITLE-ABS ( glucocorticoid-induced )  OR  TITLE-ABS ( steroid-induced ) )  OR  TITLE-ABS ( giop ) 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1,42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4248135"/>
                  </a:ext>
                </a:extLst>
              </a:tr>
              <a:tr h="145201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TITLE-ABS ( Vitamin D )  OR  TITLE-ABS ( Alfacalcidol )   OR  TITLE-ABS ( Calcitriol )   OR  TITLE-ABS ( Eldecalcitol ) 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70,567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4425445"/>
                  </a:ext>
                </a:extLst>
              </a:tr>
              <a:tr h="20182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22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3905683"/>
                  </a:ext>
                </a:extLst>
              </a:tr>
            </a:tbl>
          </a:graphicData>
        </a:graphic>
      </p:graphicFrame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077210F-B37D-F950-033B-4B7C942B5901}"/>
              </a:ext>
            </a:extLst>
          </p:cNvPr>
          <p:cNvSpPr txBox="1"/>
          <p:nvPr/>
        </p:nvSpPr>
        <p:spPr>
          <a:xfrm>
            <a:off x="93715" y="6514592"/>
            <a:ext cx="74073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Figure 1. Flow chart of literature search for CQ 7: Are active vitamin D preparations useful for treating GIOP?</a:t>
            </a:r>
          </a:p>
        </p:txBody>
      </p:sp>
      <p:pic>
        <p:nvPicPr>
          <p:cNvPr id="46" name="図 45" descr="ダイアグラム&#10;&#10;自動的に生成された説明">
            <a:extLst>
              <a:ext uri="{FF2B5EF4-FFF2-40B4-BE49-F238E27FC236}">
                <a16:creationId xmlns:a16="http://schemas.microsoft.com/office/drawing/2014/main" id="{4D5BD844-691C-852C-FA73-D9397CC566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47285" y="186436"/>
            <a:ext cx="4429317" cy="61669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14222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C91ADC0-F656-DC85-0910-D7028EC4B41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AC4D4707-37EF-0194-7D6F-7B8E274A323C}"/>
              </a:ext>
            </a:extLst>
          </p:cNvPr>
          <p:cNvSpPr txBox="1"/>
          <p:nvPr/>
        </p:nvSpPr>
        <p:spPr>
          <a:xfrm>
            <a:off x="93715" y="6514592"/>
            <a:ext cx="71380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Figure 2. Flow chart of literature search for CQ 8: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Are bisphosphonates useful for the treatment of GIOP?</a:t>
            </a:r>
            <a:r>
              <a:rPr lang="ja-JP" altLang="ja-JP" sz="12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DA07BE44-0EB1-9CEA-5C75-73BF1BA44E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3810688"/>
              </p:ext>
            </p:extLst>
          </p:nvPr>
        </p:nvGraphicFramePr>
        <p:xfrm>
          <a:off x="987046" y="281370"/>
          <a:ext cx="5744319" cy="223982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34286">
                  <a:extLst>
                    <a:ext uri="{9D8B030D-6E8A-4147-A177-3AD203B41FA5}">
                      <a16:colId xmlns:a16="http://schemas.microsoft.com/office/drawing/2014/main" val="74441575"/>
                    </a:ext>
                  </a:extLst>
                </a:gridCol>
                <a:gridCol w="512194">
                  <a:extLst>
                    <a:ext uri="{9D8B030D-6E8A-4147-A177-3AD203B41FA5}">
                      <a16:colId xmlns:a16="http://schemas.microsoft.com/office/drawing/2014/main" val="984630354"/>
                    </a:ext>
                  </a:extLst>
                </a:gridCol>
                <a:gridCol w="500282">
                  <a:extLst>
                    <a:ext uri="{9D8B030D-6E8A-4147-A177-3AD203B41FA5}">
                      <a16:colId xmlns:a16="http://schemas.microsoft.com/office/drawing/2014/main" val="3597604163"/>
                    </a:ext>
                  </a:extLst>
                </a:gridCol>
                <a:gridCol w="571752">
                  <a:extLst>
                    <a:ext uri="{9D8B030D-6E8A-4147-A177-3AD203B41FA5}">
                      <a16:colId xmlns:a16="http://schemas.microsoft.com/office/drawing/2014/main" val="3531408146"/>
                    </a:ext>
                  </a:extLst>
                </a:gridCol>
                <a:gridCol w="571752">
                  <a:extLst>
                    <a:ext uri="{9D8B030D-6E8A-4147-A177-3AD203B41FA5}">
                      <a16:colId xmlns:a16="http://schemas.microsoft.com/office/drawing/2014/main" val="648732403"/>
                    </a:ext>
                  </a:extLst>
                </a:gridCol>
                <a:gridCol w="571752">
                  <a:extLst>
                    <a:ext uri="{9D8B030D-6E8A-4147-A177-3AD203B41FA5}">
                      <a16:colId xmlns:a16="http://schemas.microsoft.com/office/drawing/2014/main" val="2500903255"/>
                    </a:ext>
                  </a:extLst>
                </a:gridCol>
                <a:gridCol w="1036301">
                  <a:extLst>
                    <a:ext uri="{9D8B030D-6E8A-4147-A177-3AD203B41FA5}">
                      <a16:colId xmlns:a16="http://schemas.microsoft.com/office/drawing/2014/main" val="321382203"/>
                    </a:ext>
                  </a:extLst>
                </a:gridCol>
                <a:gridCol w="547929">
                  <a:extLst>
                    <a:ext uri="{9D8B030D-6E8A-4147-A177-3AD203B41FA5}">
                      <a16:colId xmlns:a16="http://schemas.microsoft.com/office/drawing/2014/main" val="3622485493"/>
                    </a:ext>
                  </a:extLst>
                </a:gridCol>
                <a:gridCol w="798071">
                  <a:extLst>
                    <a:ext uri="{9D8B030D-6E8A-4147-A177-3AD203B41FA5}">
                      <a16:colId xmlns:a16="http://schemas.microsoft.com/office/drawing/2014/main" val="971612388"/>
                    </a:ext>
                  </a:extLst>
                </a:gridCol>
              </a:tblGrid>
              <a:tr h="194506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PubMed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618672317"/>
                  </a:ext>
                </a:extLst>
              </a:tr>
              <a:tr h="19450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2594603"/>
                  </a:ext>
                </a:extLst>
              </a:tr>
              <a:tr h="66456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(glucocorticoid-induced[TIAB] OR steroid-induced[TIAB]) AND (osteoporosis[TIAB] OR fracture[TIAB])) OR GIOP[TIAB]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,41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6467236"/>
                  </a:ext>
                </a:extLst>
              </a:tr>
              <a:tr h="8509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 dirty="0">
                          <a:effectLst/>
                        </a:rPr>
                        <a:t>(bisphosphonate[TIAB] OR Alendronate[TIAB] OR Ibandronate[TIAB] OR Risedronate[TIAB] OR Zoledronate[TIAB]) AND (("2000/1/1"[CRDT] : "3000"[CRDT]))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14,68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80946628"/>
                  </a:ext>
                </a:extLst>
              </a:tr>
              <a:tr h="19450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32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3152960"/>
                  </a:ext>
                </a:extLst>
              </a:tr>
            </a:tbl>
          </a:graphicData>
        </a:graphic>
      </p:graphicFrame>
      <p:pic>
        <p:nvPicPr>
          <p:cNvPr id="5" name="図 4" descr="ダイアグラム&#10;&#10;自動的に生成された説明">
            <a:extLst>
              <a:ext uri="{FF2B5EF4-FFF2-40B4-BE49-F238E27FC236}">
                <a16:creationId xmlns:a16="http://schemas.microsoft.com/office/drawing/2014/main" id="{CA455B68-2F2A-4827-3489-67E9E6EF37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98208" y="222528"/>
            <a:ext cx="4206746" cy="6224150"/>
          </a:xfrm>
          <a:prstGeom prst="rect">
            <a:avLst/>
          </a:prstGeom>
        </p:spPr>
      </p:pic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12724965-858E-448C-8CFD-921BA39D1E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0189395"/>
              </p:ext>
            </p:extLst>
          </p:nvPr>
        </p:nvGraphicFramePr>
        <p:xfrm>
          <a:off x="987046" y="2594342"/>
          <a:ext cx="5744319" cy="38040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50473">
                  <a:extLst>
                    <a:ext uri="{9D8B030D-6E8A-4147-A177-3AD203B41FA5}">
                      <a16:colId xmlns:a16="http://schemas.microsoft.com/office/drawing/2014/main" val="440920406"/>
                    </a:ext>
                  </a:extLst>
                </a:gridCol>
                <a:gridCol w="522210">
                  <a:extLst>
                    <a:ext uri="{9D8B030D-6E8A-4147-A177-3AD203B41FA5}">
                      <a16:colId xmlns:a16="http://schemas.microsoft.com/office/drawing/2014/main" val="4187190519"/>
                    </a:ext>
                  </a:extLst>
                </a:gridCol>
                <a:gridCol w="513049">
                  <a:extLst>
                    <a:ext uri="{9D8B030D-6E8A-4147-A177-3AD203B41FA5}">
                      <a16:colId xmlns:a16="http://schemas.microsoft.com/office/drawing/2014/main" val="3003516208"/>
                    </a:ext>
                  </a:extLst>
                </a:gridCol>
                <a:gridCol w="586342">
                  <a:extLst>
                    <a:ext uri="{9D8B030D-6E8A-4147-A177-3AD203B41FA5}">
                      <a16:colId xmlns:a16="http://schemas.microsoft.com/office/drawing/2014/main" val="2996506584"/>
                    </a:ext>
                  </a:extLst>
                </a:gridCol>
                <a:gridCol w="586342">
                  <a:extLst>
                    <a:ext uri="{9D8B030D-6E8A-4147-A177-3AD203B41FA5}">
                      <a16:colId xmlns:a16="http://schemas.microsoft.com/office/drawing/2014/main" val="2166865165"/>
                    </a:ext>
                  </a:extLst>
                </a:gridCol>
                <a:gridCol w="586342">
                  <a:extLst>
                    <a:ext uri="{9D8B030D-6E8A-4147-A177-3AD203B41FA5}">
                      <a16:colId xmlns:a16="http://schemas.microsoft.com/office/drawing/2014/main" val="1885014392"/>
                    </a:ext>
                  </a:extLst>
                </a:gridCol>
                <a:gridCol w="1053584">
                  <a:extLst>
                    <a:ext uri="{9D8B030D-6E8A-4147-A177-3AD203B41FA5}">
                      <a16:colId xmlns:a16="http://schemas.microsoft.com/office/drawing/2014/main" val="3144024860"/>
                    </a:ext>
                  </a:extLst>
                </a:gridCol>
                <a:gridCol w="476403">
                  <a:extLst>
                    <a:ext uri="{9D8B030D-6E8A-4147-A177-3AD203B41FA5}">
                      <a16:colId xmlns:a16="http://schemas.microsoft.com/office/drawing/2014/main" val="2379438328"/>
                    </a:ext>
                  </a:extLst>
                </a:gridCol>
                <a:gridCol w="769574">
                  <a:extLst>
                    <a:ext uri="{9D8B030D-6E8A-4147-A177-3AD203B41FA5}">
                      <a16:colId xmlns:a16="http://schemas.microsoft.com/office/drawing/2014/main" val="165156936"/>
                    </a:ext>
                  </a:extLst>
                </a:gridCol>
              </a:tblGrid>
              <a:tr h="2168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Scopus (Embase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557880505"/>
                  </a:ext>
                </a:extLst>
              </a:tr>
              <a:tr h="31797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0827467"/>
                  </a:ext>
                </a:extLst>
              </a:tr>
              <a:tr h="1517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 TITLE-ABS ( osteoporosis )  OR  TITLE-ABS ( fracture ) )  AND  ( TITLE-ABS ( glucocorticoid-induced )  OR  TITLE-ABS ( steroid-induced ) )  OR  TITLE-ABS ( giop ) 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1,42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05147724"/>
                  </a:ext>
                </a:extLst>
              </a:tr>
              <a:tr h="1517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 TITLE-ABS ( bisphosphonate )  OR  TITLE-ABS ( Alendronate )   OR  TITLE-ABS ( Ibandronate )  OR  TITLE-ABS ( Risedronate )   OR  TITLE-ABS ( Zoledronate ) )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6,085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1028156"/>
                  </a:ext>
                </a:extLst>
              </a:tr>
              <a:tr h="2168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37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875322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694833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5BC40BF-5E4B-9CF9-30B8-D30A35C07F5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8DB1E60-326C-CB4F-B31B-2178E7D414D5}"/>
              </a:ext>
            </a:extLst>
          </p:cNvPr>
          <p:cNvSpPr txBox="1"/>
          <p:nvPr/>
        </p:nvSpPr>
        <p:spPr>
          <a:xfrm>
            <a:off x="93715" y="6514592"/>
            <a:ext cx="8500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Figure 3. Flow chart of literature search for CQ 9: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Are selective estrogen receptor modulators useful for the treatment of GIOP? 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267E5A8C-8BA5-1E02-1594-55CDDC8AE5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9314870"/>
              </p:ext>
            </p:extLst>
          </p:nvPr>
        </p:nvGraphicFramePr>
        <p:xfrm>
          <a:off x="767589" y="134112"/>
          <a:ext cx="5377179" cy="23804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93748">
                  <a:extLst>
                    <a:ext uri="{9D8B030D-6E8A-4147-A177-3AD203B41FA5}">
                      <a16:colId xmlns:a16="http://schemas.microsoft.com/office/drawing/2014/main" val="2021726099"/>
                    </a:ext>
                  </a:extLst>
                </a:gridCol>
                <a:gridCol w="479459">
                  <a:extLst>
                    <a:ext uri="{9D8B030D-6E8A-4147-A177-3AD203B41FA5}">
                      <a16:colId xmlns:a16="http://schemas.microsoft.com/office/drawing/2014/main" val="1768454316"/>
                    </a:ext>
                  </a:extLst>
                </a:gridCol>
                <a:gridCol w="479459">
                  <a:extLst>
                    <a:ext uri="{9D8B030D-6E8A-4147-A177-3AD203B41FA5}">
                      <a16:colId xmlns:a16="http://schemas.microsoft.com/office/drawing/2014/main" val="1611231531"/>
                    </a:ext>
                  </a:extLst>
                </a:gridCol>
                <a:gridCol w="546359">
                  <a:extLst>
                    <a:ext uri="{9D8B030D-6E8A-4147-A177-3AD203B41FA5}">
                      <a16:colId xmlns:a16="http://schemas.microsoft.com/office/drawing/2014/main" val="3588943479"/>
                    </a:ext>
                  </a:extLst>
                </a:gridCol>
                <a:gridCol w="546359">
                  <a:extLst>
                    <a:ext uri="{9D8B030D-6E8A-4147-A177-3AD203B41FA5}">
                      <a16:colId xmlns:a16="http://schemas.microsoft.com/office/drawing/2014/main" val="2689128482"/>
                    </a:ext>
                  </a:extLst>
                </a:gridCol>
                <a:gridCol w="546359">
                  <a:extLst>
                    <a:ext uri="{9D8B030D-6E8A-4147-A177-3AD203B41FA5}">
                      <a16:colId xmlns:a16="http://schemas.microsoft.com/office/drawing/2014/main" val="3110400959"/>
                    </a:ext>
                  </a:extLst>
                </a:gridCol>
                <a:gridCol w="546359">
                  <a:extLst>
                    <a:ext uri="{9D8B030D-6E8A-4147-A177-3AD203B41FA5}">
                      <a16:colId xmlns:a16="http://schemas.microsoft.com/office/drawing/2014/main" val="3585186453"/>
                    </a:ext>
                  </a:extLst>
                </a:gridCol>
                <a:gridCol w="546359">
                  <a:extLst>
                    <a:ext uri="{9D8B030D-6E8A-4147-A177-3AD203B41FA5}">
                      <a16:colId xmlns:a16="http://schemas.microsoft.com/office/drawing/2014/main" val="863361063"/>
                    </a:ext>
                  </a:extLst>
                </a:gridCol>
                <a:gridCol w="546359">
                  <a:extLst>
                    <a:ext uri="{9D8B030D-6E8A-4147-A177-3AD203B41FA5}">
                      <a16:colId xmlns:a16="http://schemas.microsoft.com/office/drawing/2014/main" val="3891796644"/>
                    </a:ext>
                  </a:extLst>
                </a:gridCol>
                <a:gridCol w="546359">
                  <a:extLst>
                    <a:ext uri="{9D8B030D-6E8A-4147-A177-3AD203B41FA5}">
                      <a16:colId xmlns:a16="http://schemas.microsoft.com/office/drawing/2014/main" val="476916757"/>
                    </a:ext>
                  </a:extLst>
                </a:gridCol>
              </a:tblGrid>
              <a:tr h="178537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PubMed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685150527"/>
                  </a:ext>
                </a:extLst>
              </a:tr>
              <a:tr h="1785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66614356"/>
                  </a:ext>
                </a:extLst>
              </a:tr>
              <a:tr h="8728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(glucocorticoid-induced[TIAB] OR steroid-induced[TIAB]) AND (osteoporosis[TIAB] OR fracture[TIAB])) OR GIOP[TIAB]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41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94117697"/>
                  </a:ext>
                </a:extLst>
              </a:tr>
              <a:tr h="9720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"Selective estrogen receptor modulator"[TIAB] OR SERM[TIAB] OR Raloxifene[TIAB] OR Bazedoxifene[TIAB])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489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49899368"/>
                  </a:ext>
                </a:extLst>
              </a:tr>
              <a:tr h="1785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29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359722"/>
                  </a:ext>
                </a:extLst>
              </a:tr>
            </a:tbl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11CEB914-2576-4E30-981D-38D99725C1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8448598"/>
              </p:ext>
            </p:extLst>
          </p:nvPr>
        </p:nvGraphicFramePr>
        <p:xfrm>
          <a:off x="762083" y="2712844"/>
          <a:ext cx="5371308" cy="355533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93407">
                  <a:extLst>
                    <a:ext uri="{9D8B030D-6E8A-4147-A177-3AD203B41FA5}">
                      <a16:colId xmlns:a16="http://schemas.microsoft.com/office/drawing/2014/main" val="3273992277"/>
                    </a:ext>
                  </a:extLst>
                </a:gridCol>
                <a:gridCol w="476396">
                  <a:extLst>
                    <a:ext uri="{9D8B030D-6E8A-4147-A177-3AD203B41FA5}">
                      <a16:colId xmlns:a16="http://schemas.microsoft.com/office/drawing/2014/main" val="3698076228"/>
                    </a:ext>
                  </a:extLst>
                </a:gridCol>
                <a:gridCol w="479183">
                  <a:extLst>
                    <a:ext uri="{9D8B030D-6E8A-4147-A177-3AD203B41FA5}">
                      <a16:colId xmlns:a16="http://schemas.microsoft.com/office/drawing/2014/main" val="1131748574"/>
                    </a:ext>
                  </a:extLst>
                </a:gridCol>
                <a:gridCol w="546046">
                  <a:extLst>
                    <a:ext uri="{9D8B030D-6E8A-4147-A177-3AD203B41FA5}">
                      <a16:colId xmlns:a16="http://schemas.microsoft.com/office/drawing/2014/main" val="2707446429"/>
                    </a:ext>
                  </a:extLst>
                </a:gridCol>
                <a:gridCol w="546046">
                  <a:extLst>
                    <a:ext uri="{9D8B030D-6E8A-4147-A177-3AD203B41FA5}">
                      <a16:colId xmlns:a16="http://schemas.microsoft.com/office/drawing/2014/main" val="2947474852"/>
                    </a:ext>
                  </a:extLst>
                </a:gridCol>
                <a:gridCol w="546046">
                  <a:extLst>
                    <a:ext uri="{9D8B030D-6E8A-4147-A177-3AD203B41FA5}">
                      <a16:colId xmlns:a16="http://schemas.microsoft.com/office/drawing/2014/main" val="1539675817"/>
                    </a:ext>
                  </a:extLst>
                </a:gridCol>
                <a:gridCol w="546046">
                  <a:extLst>
                    <a:ext uri="{9D8B030D-6E8A-4147-A177-3AD203B41FA5}">
                      <a16:colId xmlns:a16="http://schemas.microsoft.com/office/drawing/2014/main" val="4041693994"/>
                    </a:ext>
                  </a:extLst>
                </a:gridCol>
                <a:gridCol w="546046">
                  <a:extLst>
                    <a:ext uri="{9D8B030D-6E8A-4147-A177-3AD203B41FA5}">
                      <a16:colId xmlns:a16="http://schemas.microsoft.com/office/drawing/2014/main" val="1275309822"/>
                    </a:ext>
                  </a:extLst>
                </a:gridCol>
                <a:gridCol w="546046">
                  <a:extLst>
                    <a:ext uri="{9D8B030D-6E8A-4147-A177-3AD203B41FA5}">
                      <a16:colId xmlns:a16="http://schemas.microsoft.com/office/drawing/2014/main" val="3631481321"/>
                    </a:ext>
                  </a:extLst>
                </a:gridCol>
                <a:gridCol w="546046">
                  <a:extLst>
                    <a:ext uri="{9D8B030D-6E8A-4147-A177-3AD203B41FA5}">
                      <a16:colId xmlns:a16="http://schemas.microsoft.com/office/drawing/2014/main" val="2775140421"/>
                    </a:ext>
                  </a:extLst>
                </a:gridCol>
              </a:tblGrid>
              <a:tr h="178341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Scopus(Embase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889150166"/>
                  </a:ext>
                </a:extLst>
              </a:tr>
              <a:tr h="17834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98152659"/>
                  </a:ext>
                </a:extLst>
              </a:tr>
              <a:tr h="1505994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 TITLE-ABS ( osteoporosis )  OR  TITLE-ABS ( fracture ) )  AND  ( TITLE-ABS ( glucocorticoid-induced )  OR  TITLE-ABS ( steroid-induced ) )  OR  TITLE-ABS ( giop ) 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426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5369098"/>
                  </a:ext>
                </a:extLst>
              </a:tr>
              <a:tr h="1357376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 TITLE-ABS ( Selective estrogen receptor modulator )  OR  TITLE-ABS ( SERM )   OR  TITLE-ABS ( Raloxifene )  OR  TITLE-ABS ( Bazedoxifene ) )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6918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3670669"/>
                  </a:ext>
                </a:extLst>
              </a:tr>
              <a:tr h="178341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4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71246282"/>
                  </a:ext>
                </a:extLst>
              </a:tr>
            </a:tbl>
          </a:graphicData>
        </a:graphic>
      </p:graphicFrame>
      <p:pic>
        <p:nvPicPr>
          <p:cNvPr id="8" name="図 7" descr="ダイアグラム&#10;&#10;自動的に生成された説明">
            <a:extLst>
              <a:ext uri="{FF2B5EF4-FFF2-40B4-BE49-F238E27FC236}">
                <a16:creationId xmlns:a16="http://schemas.microsoft.com/office/drawing/2014/main" id="{3A0EED51-D77B-2D7A-E2DE-2A56A4AE42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34912" y="81649"/>
            <a:ext cx="4267200" cy="6235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11935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C63DA3C-B36D-DF55-C69D-F3D05BD564C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CDD4417-BD72-58AE-3D03-960D32A0F01A}"/>
              </a:ext>
            </a:extLst>
          </p:cNvPr>
          <p:cNvSpPr txBox="1"/>
          <p:nvPr/>
        </p:nvSpPr>
        <p:spPr>
          <a:xfrm>
            <a:off x="93715" y="6514592"/>
            <a:ext cx="8133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Figure 4. Flow chart of literature search for CQ 10: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Are parathyroid hormone 1 receptor agonists useful in treating GIOP?</a:t>
            </a:r>
            <a:r>
              <a:rPr lang="ja-JP" altLang="ja-JP" sz="12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859F82B7-1DE9-B1C2-A66B-1931576D44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6215874"/>
              </p:ext>
            </p:extLst>
          </p:nvPr>
        </p:nvGraphicFramePr>
        <p:xfrm>
          <a:off x="705613" y="365760"/>
          <a:ext cx="5756148" cy="224350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30364">
                  <a:extLst>
                    <a:ext uri="{9D8B030D-6E8A-4147-A177-3AD203B41FA5}">
                      <a16:colId xmlns:a16="http://schemas.microsoft.com/office/drawing/2014/main" val="1084753221"/>
                    </a:ext>
                  </a:extLst>
                </a:gridCol>
                <a:gridCol w="509027">
                  <a:extLst>
                    <a:ext uri="{9D8B030D-6E8A-4147-A177-3AD203B41FA5}">
                      <a16:colId xmlns:a16="http://schemas.microsoft.com/office/drawing/2014/main" val="946719400"/>
                    </a:ext>
                  </a:extLst>
                </a:gridCol>
                <a:gridCol w="509027">
                  <a:extLst>
                    <a:ext uri="{9D8B030D-6E8A-4147-A177-3AD203B41FA5}">
                      <a16:colId xmlns:a16="http://schemas.microsoft.com/office/drawing/2014/main" val="4007158683"/>
                    </a:ext>
                  </a:extLst>
                </a:gridCol>
                <a:gridCol w="580054">
                  <a:extLst>
                    <a:ext uri="{9D8B030D-6E8A-4147-A177-3AD203B41FA5}">
                      <a16:colId xmlns:a16="http://schemas.microsoft.com/office/drawing/2014/main" val="1372345303"/>
                    </a:ext>
                  </a:extLst>
                </a:gridCol>
                <a:gridCol w="580054">
                  <a:extLst>
                    <a:ext uri="{9D8B030D-6E8A-4147-A177-3AD203B41FA5}">
                      <a16:colId xmlns:a16="http://schemas.microsoft.com/office/drawing/2014/main" val="1615326294"/>
                    </a:ext>
                  </a:extLst>
                </a:gridCol>
                <a:gridCol w="580054">
                  <a:extLst>
                    <a:ext uri="{9D8B030D-6E8A-4147-A177-3AD203B41FA5}">
                      <a16:colId xmlns:a16="http://schemas.microsoft.com/office/drawing/2014/main" val="1500383215"/>
                    </a:ext>
                  </a:extLst>
                </a:gridCol>
                <a:gridCol w="958865">
                  <a:extLst>
                    <a:ext uri="{9D8B030D-6E8A-4147-A177-3AD203B41FA5}">
                      <a16:colId xmlns:a16="http://schemas.microsoft.com/office/drawing/2014/main" val="3302349250"/>
                    </a:ext>
                  </a:extLst>
                </a:gridCol>
                <a:gridCol w="580054">
                  <a:extLst>
                    <a:ext uri="{9D8B030D-6E8A-4147-A177-3AD203B41FA5}">
                      <a16:colId xmlns:a16="http://schemas.microsoft.com/office/drawing/2014/main" val="4122820894"/>
                    </a:ext>
                  </a:extLst>
                </a:gridCol>
                <a:gridCol w="828649">
                  <a:extLst>
                    <a:ext uri="{9D8B030D-6E8A-4147-A177-3AD203B41FA5}">
                      <a16:colId xmlns:a16="http://schemas.microsoft.com/office/drawing/2014/main" val="2665302655"/>
                    </a:ext>
                  </a:extLst>
                </a:gridCol>
              </a:tblGrid>
              <a:tr h="175125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PubMed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73965583"/>
                  </a:ext>
                </a:extLst>
              </a:tr>
              <a:tr h="51370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u="none" strike="noStrike">
                          <a:effectLst/>
                        </a:rPr>
                        <a:t>　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884153473"/>
                  </a:ext>
                </a:extLst>
              </a:tr>
              <a:tr h="62023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(glucocorticoid-induced[TIAB] OR steroid-induced[TIAB]) AND (osteoporosis[TIAB] OR fracture[TIAB])) OR GIOP[TIAB]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</a:rPr>
                        <a:t>1,413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8575246"/>
                  </a:ext>
                </a:extLst>
              </a:tr>
              <a:tr h="53267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PTH[TIAB] OR Parathyroid[TIAB] OR Teriparatide[TIAB])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</a:rPr>
                        <a:t>35,40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9554257"/>
                  </a:ext>
                </a:extLst>
              </a:tr>
              <a:tr h="19458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</a:rPr>
                        <a:t>230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31653943"/>
                  </a:ext>
                </a:extLst>
              </a:tr>
            </a:tbl>
          </a:graphicData>
        </a:graphic>
      </p:graphicFrame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7CB31C3B-7A44-9540-74A0-0EFB3E336A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1772952"/>
              </p:ext>
            </p:extLst>
          </p:nvPr>
        </p:nvGraphicFramePr>
        <p:xfrm>
          <a:off x="667510" y="2753866"/>
          <a:ext cx="5794249" cy="33460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30969">
                  <a:extLst>
                    <a:ext uri="{9D8B030D-6E8A-4147-A177-3AD203B41FA5}">
                      <a16:colId xmlns:a16="http://schemas.microsoft.com/office/drawing/2014/main" val="1253226471"/>
                    </a:ext>
                  </a:extLst>
                </a:gridCol>
                <a:gridCol w="506552">
                  <a:extLst>
                    <a:ext uri="{9D8B030D-6E8A-4147-A177-3AD203B41FA5}">
                      <a16:colId xmlns:a16="http://schemas.microsoft.com/office/drawing/2014/main" val="2575030290"/>
                    </a:ext>
                  </a:extLst>
                </a:gridCol>
                <a:gridCol w="509515">
                  <a:extLst>
                    <a:ext uri="{9D8B030D-6E8A-4147-A177-3AD203B41FA5}">
                      <a16:colId xmlns:a16="http://schemas.microsoft.com/office/drawing/2014/main" val="3321985373"/>
                    </a:ext>
                  </a:extLst>
                </a:gridCol>
                <a:gridCol w="580610">
                  <a:extLst>
                    <a:ext uri="{9D8B030D-6E8A-4147-A177-3AD203B41FA5}">
                      <a16:colId xmlns:a16="http://schemas.microsoft.com/office/drawing/2014/main" val="1930741036"/>
                    </a:ext>
                  </a:extLst>
                </a:gridCol>
                <a:gridCol w="580610">
                  <a:extLst>
                    <a:ext uri="{9D8B030D-6E8A-4147-A177-3AD203B41FA5}">
                      <a16:colId xmlns:a16="http://schemas.microsoft.com/office/drawing/2014/main" val="2537049725"/>
                    </a:ext>
                  </a:extLst>
                </a:gridCol>
                <a:gridCol w="580610">
                  <a:extLst>
                    <a:ext uri="{9D8B030D-6E8A-4147-A177-3AD203B41FA5}">
                      <a16:colId xmlns:a16="http://schemas.microsoft.com/office/drawing/2014/main" val="114113346"/>
                    </a:ext>
                  </a:extLst>
                </a:gridCol>
                <a:gridCol w="1042727">
                  <a:extLst>
                    <a:ext uri="{9D8B030D-6E8A-4147-A177-3AD203B41FA5}">
                      <a16:colId xmlns:a16="http://schemas.microsoft.com/office/drawing/2014/main" val="3347404796"/>
                    </a:ext>
                  </a:extLst>
                </a:gridCol>
                <a:gridCol w="580610">
                  <a:extLst>
                    <a:ext uri="{9D8B030D-6E8A-4147-A177-3AD203B41FA5}">
                      <a16:colId xmlns:a16="http://schemas.microsoft.com/office/drawing/2014/main" val="1460965617"/>
                    </a:ext>
                  </a:extLst>
                </a:gridCol>
                <a:gridCol w="782046">
                  <a:extLst>
                    <a:ext uri="{9D8B030D-6E8A-4147-A177-3AD203B41FA5}">
                      <a16:colId xmlns:a16="http://schemas.microsoft.com/office/drawing/2014/main" val="1622871184"/>
                    </a:ext>
                  </a:extLst>
                </a:gridCol>
              </a:tblGrid>
              <a:tr h="17512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Scopus(Embase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21362953"/>
                  </a:ext>
                </a:extLst>
              </a:tr>
              <a:tr h="51370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u="none" strike="noStrike">
                          <a:effectLst/>
                        </a:rPr>
                        <a:t>　</a:t>
                      </a:r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84153817"/>
                  </a:ext>
                </a:extLst>
              </a:tr>
              <a:tr h="12842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 dirty="0">
                          <a:effectLst/>
                        </a:rPr>
                        <a:t>( TITLE-ABS ( osteoporosis )  OR  TITLE-ABS ( fracture ) )  AND  ( TITLE-ABS ( glucocorticoid-induced )  OR  TITLE-ABS ( steroid-induced ) )  OR  TITLE-ABS ( </a:t>
                      </a:r>
                      <a:r>
                        <a:rPr lang="en" sz="1100" u="none" strike="noStrike" dirty="0" err="1">
                          <a:effectLst/>
                        </a:rPr>
                        <a:t>giop</a:t>
                      </a:r>
                      <a:r>
                        <a:rPr lang="en" sz="1100" u="none" strike="noStrike" dirty="0">
                          <a:effectLst/>
                        </a:rPr>
                        <a:t> ) 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</a:rPr>
                        <a:t>1,426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0910542"/>
                  </a:ext>
                </a:extLst>
              </a:tr>
              <a:tr h="102156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 TITLE-ABS ( PTH )  OR  TITLE-ABS ( Parathyroid )   OR  TITLE-ABS ( Teriparatide ) )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>
                          <a:effectLst/>
                        </a:rPr>
                        <a:t>37,552</a:t>
                      </a:r>
                      <a:endParaRPr lang="en-US" altLang="ja-JP" sz="12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1783572"/>
                  </a:ext>
                </a:extLst>
              </a:tr>
              <a:tr h="19458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</a:rPr>
                        <a:t>221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34" charset="-128"/>
                        <a:ea typeface="游ゴシック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0045964"/>
                  </a:ext>
                </a:extLst>
              </a:tr>
            </a:tbl>
          </a:graphicData>
        </a:graphic>
      </p:graphicFrame>
      <p:pic>
        <p:nvPicPr>
          <p:cNvPr id="7" name="図 6" descr="ダイアグラム&#10;&#10;自動的に生成された説明">
            <a:extLst>
              <a:ext uri="{FF2B5EF4-FFF2-40B4-BE49-F238E27FC236}">
                <a16:creationId xmlns:a16="http://schemas.microsoft.com/office/drawing/2014/main" id="{F1A1C0EE-BA4D-3953-8892-D30C7CA175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60012" y="355600"/>
            <a:ext cx="3999682" cy="5744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63226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37A293-6FC6-6CF2-5E52-1FC41257869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73353C6-AD65-668D-E468-67ED1D3810CF}"/>
              </a:ext>
            </a:extLst>
          </p:cNvPr>
          <p:cNvSpPr txBox="1"/>
          <p:nvPr/>
        </p:nvSpPr>
        <p:spPr>
          <a:xfrm>
            <a:off x="93715" y="6514592"/>
            <a:ext cx="7649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Figure 5. Flow chart of literature search for CQ 11: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Is an anti-RANKL antibody useful for the treatment of GIOP?</a:t>
            </a:r>
            <a:r>
              <a:rPr lang="ja-JP" altLang="ja-JP" sz="12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A39AD5C0-E387-06D7-A090-15ADC7E71A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7597279"/>
              </p:ext>
            </p:extLst>
          </p:nvPr>
        </p:nvGraphicFramePr>
        <p:xfrm>
          <a:off x="458978" y="396050"/>
          <a:ext cx="6324598" cy="22008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11267">
                  <a:extLst>
                    <a:ext uri="{9D8B030D-6E8A-4147-A177-3AD203B41FA5}">
                      <a16:colId xmlns:a16="http://schemas.microsoft.com/office/drawing/2014/main" val="1682584631"/>
                    </a:ext>
                  </a:extLst>
                </a:gridCol>
                <a:gridCol w="574356">
                  <a:extLst>
                    <a:ext uri="{9D8B030D-6E8A-4147-A177-3AD203B41FA5}">
                      <a16:colId xmlns:a16="http://schemas.microsoft.com/office/drawing/2014/main" val="2105022582"/>
                    </a:ext>
                  </a:extLst>
                </a:gridCol>
                <a:gridCol w="574356">
                  <a:extLst>
                    <a:ext uri="{9D8B030D-6E8A-4147-A177-3AD203B41FA5}">
                      <a16:colId xmlns:a16="http://schemas.microsoft.com/office/drawing/2014/main" val="2693876786"/>
                    </a:ext>
                  </a:extLst>
                </a:gridCol>
                <a:gridCol w="654499">
                  <a:extLst>
                    <a:ext uri="{9D8B030D-6E8A-4147-A177-3AD203B41FA5}">
                      <a16:colId xmlns:a16="http://schemas.microsoft.com/office/drawing/2014/main" val="1364855333"/>
                    </a:ext>
                  </a:extLst>
                </a:gridCol>
                <a:gridCol w="654499">
                  <a:extLst>
                    <a:ext uri="{9D8B030D-6E8A-4147-A177-3AD203B41FA5}">
                      <a16:colId xmlns:a16="http://schemas.microsoft.com/office/drawing/2014/main" val="1572096908"/>
                    </a:ext>
                  </a:extLst>
                </a:gridCol>
                <a:gridCol w="654499">
                  <a:extLst>
                    <a:ext uri="{9D8B030D-6E8A-4147-A177-3AD203B41FA5}">
                      <a16:colId xmlns:a16="http://schemas.microsoft.com/office/drawing/2014/main" val="2144386939"/>
                    </a:ext>
                  </a:extLst>
                </a:gridCol>
                <a:gridCol w="975070">
                  <a:extLst>
                    <a:ext uri="{9D8B030D-6E8A-4147-A177-3AD203B41FA5}">
                      <a16:colId xmlns:a16="http://schemas.microsoft.com/office/drawing/2014/main" val="1317051036"/>
                    </a:ext>
                  </a:extLst>
                </a:gridCol>
                <a:gridCol w="654499">
                  <a:extLst>
                    <a:ext uri="{9D8B030D-6E8A-4147-A177-3AD203B41FA5}">
                      <a16:colId xmlns:a16="http://schemas.microsoft.com/office/drawing/2014/main" val="1163414770"/>
                    </a:ext>
                  </a:extLst>
                </a:gridCol>
                <a:gridCol w="871553">
                  <a:extLst>
                    <a:ext uri="{9D8B030D-6E8A-4147-A177-3AD203B41FA5}">
                      <a16:colId xmlns:a16="http://schemas.microsoft.com/office/drawing/2014/main" val="3851826205"/>
                    </a:ext>
                  </a:extLst>
                </a:gridCol>
              </a:tblGrid>
              <a:tr h="243412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PubMed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553084642"/>
                  </a:ext>
                </a:extLst>
              </a:tr>
              <a:tr h="24341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7266398"/>
                  </a:ext>
                </a:extLst>
              </a:tr>
              <a:tr h="86208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(glucocorticoid-induced[TIAB] OR steroid-induced[TIAB]) AND (osteoporosis[TIAB] OR fracture[TIAB])) OR GIOP[TIAB]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,41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861991"/>
                  </a:ext>
                </a:extLst>
              </a:tr>
              <a:tr h="60852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RANKL[TIAB] OR Denosumab[TIAB])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14,529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0278652"/>
                  </a:ext>
                </a:extLst>
              </a:tr>
              <a:tr h="24341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129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5079306"/>
                  </a:ext>
                </a:extLst>
              </a:tr>
            </a:tbl>
          </a:graphicData>
        </a:graphic>
      </p:graphicFrame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EBD9BB5E-9CD9-B220-E9F4-E4E8DB8C37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3736767"/>
              </p:ext>
            </p:extLst>
          </p:nvPr>
        </p:nvGraphicFramePr>
        <p:xfrm>
          <a:off x="458978" y="2822289"/>
          <a:ext cx="6324600" cy="34671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6275">
                  <a:extLst>
                    <a:ext uri="{9D8B030D-6E8A-4147-A177-3AD203B41FA5}">
                      <a16:colId xmlns:a16="http://schemas.microsoft.com/office/drawing/2014/main" val="4144309436"/>
                    </a:ext>
                  </a:extLst>
                </a:gridCol>
                <a:gridCol w="542925">
                  <a:extLst>
                    <a:ext uri="{9D8B030D-6E8A-4147-A177-3AD203B41FA5}">
                      <a16:colId xmlns:a16="http://schemas.microsoft.com/office/drawing/2014/main" val="902728000"/>
                    </a:ext>
                  </a:extLst>
                </a:gridCol>
                <a:gridCol w="546100">
                  <a:extLst>
                    <a:ext uri="{9D8B030D-6E8A-4147-A177-3AD203B41FA5}">
                      <a16:colId xmlns:a16="http://schemas.microsoft.com/office/drawing/2014/main" val="187747514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1637195925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331630897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4242994223"/>
                    </a:ext>
                  </a:extLst>
                </a:gridCol>
                <a:gridCol w="1193800">
                  <a:extLst>
                    <a:ext uri="{9D8B030D-6E8A-4147-A177-3AD203B41FA5}">
                      <a16:colId xmlns:a16="http://schemas.microsoft.com/office/drawing/2014/main" val="2910757853"/>
                    </a:ext>
                  </a:extLst>
                </a:gridCol>
                <a:gridCol w="622300">
                  <a:extLst>
                    <a:ext uri="{9D8B030D-6E8A-4147-A177-3AD203B41FA5}">
                      <a16:colId xmlns:a16="http://schemas.microsoft.com/office/drawing/2014/main" val="2995050413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191396077"/>
                    </a:ext>
                  </a:extLst>
                </a:gridCol>
              </a:tblGrid>
              <a:tr h="2286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Scopus (Embase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18763718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3523889"/>
                  </a:ext>
                </a:extLst>
              </a:tr>
              <a:tr h="16764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 TITLE-ABS ( osteoporosis )  OR  TITLE-ABS ( fracture ) )  AND  ( TITLE-ABS ( glucocorticoid-induced )  OR  TITLE-ABS ( steroid-induced ) )  OR  TITLE-ABS ( giop ) 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,426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71908487"/>
                  </a:ext>
                </a:extLst>
              </a:tr>
              <a:tr h="1333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 TITLE-ABS ( RANKL )  OR  TITLE-ABS ( Denosumab ) )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14,11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1757118"/>
                  </a:ext>
                </a:extLst>
              </a:tr>
            </a:tbl>
          </a:graphicData>
        </a:graphic>
      </p:graphicFrame>
      <p:pic>
        <p:nvPicPr>
          <p:cNvPr id="10" name="図 9" descr="ダイアグラム&#10;&#10;自動的に生成された説明">
            <a:extLst>
              <a:ext uri="{FF2B5EF4-FFF2-40B4-BE49-F238E27FC236}">
                <a16:creationId xmlns:a16="http://schemas.microsoft.com/office/drawing/2014/main" id="{5EF4D0B9-F5C7-8ABF-7CCD-D1D96D1E27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12887" y="396050"/>
            <a:ext cx="4329126" cy="58933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7153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829F41F-AF12-01AB-7097-9454DF20862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3A3EC3D-45F0-063C-A01A-C84CA3B9F11B}"/>
              </a:ext>
            </a:extLst>
          </p:cNvPr>
          <p:cNvSpPr txBox="1"/>
          <p:nvPr/>
        </p:nvSpPr>
        <p:spPr>
          <a:xfrm>
            <a:off x="93715" y="6514592"/>
            <a:ext cx="7655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Figure 6. Flow chart of literature search for CQ 12: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Is an anti-sclerostin antibody useful for the treatment of GIOP? 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D40013C5-3A37-819B-4FD9-9DA08CF9F5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0122760"/>
              </p:ext>
            </p:extLst>
          </p:nvPr>
        </p:nvGraphicFramePr>
        <p:xfrm>
          <a:off x="515112" y="387287"/>
          <a:ext cx="5943600" cy="23545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5914">
                  <a:extLst>
                    <a:ext uri="{9D8B030D-6E8A-4147-A177-3AD203B41FA5}">
                      <a16:colId xmlns:a16="http://schemas.microsoft.com/office/drawing/2014/main" val="622046383"/>
                    </a:ext>
                  </a:extLst>
                </a:gridCol>
                <a:gridCol w="545808">
                  <a:extLst>
                    <a:ext uri="{9D8B030D-6E8A-4147-A177-3AD203B41FA5}">
                      <a16:colId xmlns:a16="http://schemas.microsoft.com/office/drawing/2014/main" val="1905846967"/>
                    </a:ext>
                  </a:extLst>
                </a:gridCol>
                <a:gridCol w="545808">
                  <a:extLst>
                    <a:ext uri="{9D8B030D-6E8A-4147-A177-3AD203B41FA5}">
                      <a16:colId xmlns:a16="http://schemas.microsoft.com/office/drawing/2014/main" val="3316142045"/>
                    </a:ext>
                  </a:extLst>
                </a:gridCol>
                <a:gridCol w="621968">
                  <a:extLst>
                    <a:ext uri="{9D8B030D-6E8A-4147-A177-3AD203B41FA5}">
                      <a16:colId xmlns:a16="http://schemas.microsoft.com/office/drawing/2014/main" val="132925614"/>
                    </a:ext>
                  </a:extLst>
                </a:gridCol>
                <a:gridCol w="621968">
                  <a:extLst>
                    <a:ext uri="{9D8B030D-6E8A-4147-A177-3AD203B41FA5}">
                      <a16:colId xmlns:a16="http://schemas.microsoft.com/office/drawing/2014/main" val="138825738"/>
                    </a:ext>
                  </a:extLst>
                </a:gridCol>
                <a:gridCol w="621968">
                  <a:extLst>
                    <a:ext uri="{9D8B030D-6E8A-4147-A177-3AD203B41FA5}">
                      <a16:colId xmlns:a16="http://schemas.microsoft.com/office/drawing/2014/main" val="2093261975"/>
                    </a:ext>
                  </a:extLst>
                </a:gridCol>
                <a:gridCol w="1066230">
                  <a:extLst>
                    <a:ext uri="{9D8B030D-6E8A-4147-A177-3AD203B41FA5}">
                      <a16:colId xmlns:a16="http://schemas.microsoft.com/office/drawing/2014/main" val="1821686823"/>
                    </a:ext>
                  </a:extLst>
                </a:gridCol>
                <a:gridCol w="621968">
                  <a:extLst>
                    <a:ext uri="{9D8B030D-6E8A-4147-A177-3AD203B41FA5}">
                      <a16:colId xmlns:a16="http://schemas.microsoft.com/office/drawing/2014/main" val="3359968817"/>
                    </a:ext>
                  </a:extLst>
                </a:gridCol>
                <a:gridCol w="621968">
                  <a:extLst>
                    <a:ext uri="{9D8B030D-6E8A-4147-A177-3AD203B41FA5}">
                      <a16:colId xmlns:a16="http://schemas.microsoft.com/office/drawing/2014/main" val="1465501910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PubMed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4613197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4784503"/>
                  </a:ext>
                </a:extLst>
              </a:tr>
              <a:tr h="80962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(glucocorticoid-induced[TIAB] OR steroid-induced[TIAB]) AND (osteoporosis[TIAB] OR fracture[TIAB])) OR GIOP[TIAB]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,41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65843248"/>
                  </a:ext>
                </a:extLst>
              </a:tr>
              <a:tr h="7524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Sclerostin[TIAB] OR Romosozumab[TIAB])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,564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374243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2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80785540"/>
                  </a:ext>
                </a:extLst>
              </a:tr>
            </a:tbl>
          </a:graphicData>
        </a:graphic>
      </p:graphicFrame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F1E9F34A-D73D-7F21-C02F-50599B0D68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8946640"/>
              </p:ext>
            </p:extLst>
          </p:nvPr>
        </p:nvGraphicFramePr>
        <p:xfrm>
          <a:off x="515112" y="2820733"/>
          <a:ext cx="5943599" cy="355327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2127">
                  <a:extLst>
                    <a:ext uri="{9D8B030D-6E8A-4147-A177-3AD203B41FA5}">
                      <a16:colId xmlns:a16="http://schemas.microsoft.com/office/drawing/2014/main" val="4044037115"/>
                    </a:ext>
                  </a:extLst>
                </a:gridCol>
                <a:gridCol w="531567">
                  <a:extLst>
                    <a:ext uri="{9D8B030D-6E8A-4147-A177-3AD203B41FA5}">
                      <a16:colId xmlns:a16="http://schemas.microsoft.com/office/drawing/2014/main" val="3711959050"/>
                    </a:ext>
                  </a:extLst>
                </a:gridCol>
                <a:gridCol w="534675">
                  <a:extLst>
                    <a:ext uri="{9D8B030D-6E8A-4147-A177-3AD203B41FA5}">
                      <a16:colId xmlns:a16="http://schemas.microsoft.com/office/drawing/2014/main" val="1893686522"/>
                    </a:ext>
                  </a:extLst>
                </a:gridCol>
                <a:gridCol w="609281">
                  <a:extLst>
                    <a:ext uri="{9D8B030D-6E8A-4147-A177-3AD203B41FA5}">
                      <a16:colId xmlns:a16="http://schemas.microsoft.com/office/drawing/2014/main" val="1039911991"/>
                    </a:ext>
                  </a:extLst>
                </a:gridCol>
                <a:gridCol w="609281">
                  <a:extLst>
                    <a:ext uri="{9D8B030D-6E8A-4147-A177-3AD203B41FA5}">
                      <a16:colId xmlns:a16="http://schemas.microsoft.com/office/drawing/2014/main" val="596490654"/>
                    </a:ext>
                  </a:extLst>
                </a:gridCol>
                <a:gridCol w="609281">
                  <a:extLst>
                    <a:ext uri="{9D8B030D-6E8A-4147-A177-3AD203B41FA5}">
                      <a16:colId xmlns:a16="http://schemas.microsoft.com/office/drawing/2014/main" val="2180141026"/>
                    </a:ext>
                  </a:extLst>
                </a:gridCol>
                <a:gridCol w="1168825">
                  <a:extLst>
                    <a:ext uri="{9D8B030D-6E8A-4147-A177-3AD203B41FA5}">
                      <a16:colId xmlns:a16="http://schemas.microsoft.com/office/drawing/2014/main" val="1327513391"/>
                    </a:ext>
                  </a:extLst>
                </a:gridCol>
                <a:gridCol w="609281">
                  <a:extLst>
                    <a:ext uri="{9D8B030D-6E8A-4147-A177-3AD203B41FA5}">
                      <a16:colId xmlns:a16="http://schemas.microsoft.com/office/drawing/2014/main" val="1540241452"/>
                    </a:ext>
                  </a:extLst>
                </a:gridCol>
                <a:gridCol w="609281">
                  <a:extLst>
                    <a:ext uri="{9D8B030D-6E8A-4147-A177-3AD203B41FA5}">
                      <a16:colId xmlns:a16="http://schemas.microsoft.com/office/drawing/2014/main" val="225126481"/>
                    </a:ext>
                  </a:extLst>
                </a:gridCol>
              </a:tblGrid>
              <a:tr h="221931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Scopus (Embase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824146684"/>
                  </a:ext>
                </a:extLst>
              </a:tr>
              <a:tr h="32549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0740936"/>
                  </a:ext>
                </a:extLst>
              </a:tr>
              <a:tr h="147953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 TITLE-ABS ( osteoporosis )  OR  TITLE-ABS ( fracture ) )  AND  ( TITLE-ABS ( glucocorticoid-induced )  OR  TITLE-ABS ( steroid-induced ) )  OR  TITLE-ABS ( giop ) 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,426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74654345"/>
                  </a:ext>
                </a:extLst>
              </a:tr>
              <a:tr h="129459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 TITLE-ABS ( Sclerostin )  OR  TITLE-ABS ( Romosozumab ) ) AND  PUBYEAR  &gt;  1999  AND  ( EXCLUDE ( DOCTYPE ,  "er" )  OR  EXCLUDE ( DOCTYPE ,  "tb" ) )  AND  ( LIMIT-TO ( LANGUAGE ,  "English" )  OR  LIMIT-TO ( LANGUAGE ,  "Japanese" ) )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,486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6644424"/>
                  </a:ext>
                </a:extLst>
              </a:tr>
              <a:tr h="22193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1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36794839"/>
                  </a:ext>
                </a:extLst>
              </a:tr>
            </a:tbl>
          </a:graphicData>
        </a:graphic>
      </p:graphicFrame>
      <p:pic>
        <p:nvPicPr>
          <p:cNvPr id="5" name="図 4" descr="ダイアグラム&#10;&#10;自動的に生成された説明">
            <a:extLst>
              <a:ext uri="{FF2B5EF4-FFF2-40B4-BE49-F238E27FC236}">
                <a16:creationId xmlns:a16="http://schemas.microsoft.com/office/drawing/2014/main" id="{ED085575-26AA-0B88-8396-432EBFADA1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91259" y="387287"/>
            <a:ext cx="4425456" cy="598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50004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C676F7A-EEC6-8B17-2CF1-C1FBBCBBBE1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79F680C-949F-7E93-57AD-414AE51D7F91}"/>
              </a:ext>
            </a:extLst>
          </p:cNvPr>
          <p:cNvSpPr txBox="1"/>
          <p:nvPr/>
        </p:nvSpPr>
        <p:spPr>
          <a:xfrm>
            <a:off x="93715" y="6514592"/>
            <a:ext cx="77235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Figure 7. Flow chart of literature search for CQ 13: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Are the above-described drugs different in terms of usefulness? 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04283BA6-81CC-F787-C3F4-556FF550D7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0511539"/>
              </p:ext>
            </p:extLst>
          </p:nvPr>
        </p:nvGraphicFramePr>
        <p:xfrm>
          <a:off x="374130" y="90609"/>
          <a:ext cx="6404623" cy="28107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30691">
                  <a:extLst>
                    <a:ext uri="{9D8B030D-6E8A-4147-A177-3AD203B41FA5}">
                      <a16:colId xmlns:a16="http://schemas.microsoft.com/office/drawing/2014/main" val="3378967270"/>
                    </a:ext>
                  </a:extLst>
                </a:gridCol>
                <a:gridCol w="509292">
                  <a:extLst>
                    <a:ext uri="{9D8B030D-6E8A-4147-A177-3AD203B41FA5}">
                      <a16:colId xmlns:a16="http://schemas.microsoft.com/office/drawing/2014/main" val="2742589932"/>
                    </a:ext>
                  </a:extLst>
                </a:gridCol>
                <a:gridCol w="509292">
                  <a:extLst>
                    <a:ext uri="{9D8B030D-6E8A-4147-A177-3AD203B41FA5}">
                      <a16:colId xmlns:a16="http://schemas.microsoft.com/office/drawing/2014/main" val="2174409918"/>
                    </a:ext>
                  </a:extLst>
                </a:gridCol>
                <a:gridCol w="580354">
                  <a:extLst>
                    <a:ext uri="{9D8B030D-6E8A-4147-A177-3AD203B41FA5}">
                      <a16:colId xmlns:a16="http://schemas.microsoft.com/office/drawing/2014/main" val="3638097295"/>
                    </a:ext>
                  </a:extLst>
                </a:gridCol>
                <a:gridCol w="580354">
                  <a:extLst>
                    <a:ext uri="{9D8B030D-6E8A-4147-A177-3AD203B41FA5}">
                      <a16:colId xmlns:a16="http://schemas.microsoft.com/office/drawing/2014/main" val="4048286246"/>
                    </a:ext>
                  </a:extLst>
                </a:gridCol>
                <a:gridCol w="580354">
                  <a:extLst>
                    <a:ext uri="{9D8B030D-6E8A-4147-A177-3AD203B41FA5}">
                      <a16:colId xmlns:a16="http://schemas.microsoft.com/office/drawing/2014/main" val="2717429674"/>
                    </a:ext>
                  </a:extLst>
                </a:gridCol>
                <a:gridCol w="1660973">
                  <a:extLst>
                    <a:ext uri="{9D8B030D-6E8A-4147-A177-3AD203B41FA5}">
                      <a16:colId xmlns:a16="http://schemas.microsoft.com/office/drawing/2014/main" val="1576594275"/>
                    </a:ext>
                  </a:extLst>
                </a:gridCol>
                <a:gridCol w="367304">
                  <a:extLst>
                    <a:ext uri="{9D8B030D-6E8A-4147-A177-3AD203B41FA5}">
                      <a16:colId xmlns:a16="http://schemas.microsoft.com/office/drawing/2014/main" val="1924900835"/>
                    </a:ext>
                  </a:extLst>
                </a:gridCol>
                <a:gridCol w="986009">
                  <a:extLst>
                    <a:ext uri="{9D8B030D-6E8A-4147-A177-3AD203B41FA5}">
                      <a16:colId xmlns:a16="http://schemas.microsoft.com/office/drawing/2014/main" val="2967367427"/>
                    </a:ext>
                  </a:extLst>
                </a:gridCol>
              </a:tblGrid>
              <a:tr h="160760"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</a:rPr>
                        <a:t>PubMed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858115141"/>
                  </a:ext>
                </a:extLst>
              </a:tr>
              <a:tr h="32152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#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literature search formula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number of references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1743548"/>
                  </a:ext>
                </a:extLst>
              </a:tr>
              <a:tr h="57072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(glucocorticoid-induced[TIAB] OR steroid-induced[TIAB]) AND (osteoporosis[TIAB] OR fracture[TIAB])) OR GIOP[TIAB]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1,41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1807065"/>
                  </a:ext>
                </a:extLst>
              </a:tr>
              <a:tr h="156948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2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("Vitamin D"[TIAB] OR Alfacalcidol[TIAB] OR Calcitriol[TIAB] OR Eldecalcitol[TIAB] OR bisphosphonate[TIAB] OR Alendronate[TIAB] OR Ibandronate[TIAB] OR Risedronate[TIAB] OR Zoledronate[TIAB] OR "Selective estrogen receptor modulator"[TIAB] OR SERM[TIAB] OR Raloxifene[TIAB] OR Bazedoxifene[TIAB] OR PTH[TIAB] OR Parathyroid[TIAB] OR Teriparatide[TIAB] OR RANKL[TIAB] OR Denosumab[TIAB]　OR Sclerostin[TIAB] OR Romosozumab[TIAB]) AND (("2000/1/1"[CRDT] : "3000"[CRDT]))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116,37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49777477"/>
                  </a:ext>
                </a:extLst>
              </a:tr>
              <a:tr h="16076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</a:rPr>
                        <a:t>#1 AND #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</a:rPr>
                        <a:t>66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9936057"/>
                  </a:ext>
                </a:extLst>
              </a:tr>
            </a:tbl>
          </a:graphicData>
        </a:graphic>
      </p:graphicFrame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A1A864C9-30A5-5656-4D3C-3EC1877384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4403779"/>
              </p:ext>
            </p:extLst>
          </p:nvPr>
        </p:nvGraphicFramePr>
        <p:xfrm>
          <a:off x="374131" y="2994897"/>
          <a:ext cx="6404622" cy="33986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20649">
                  <a:extLst>
                    <a:ext uri="{9D8B030D-6E8A-4147-A177-3AD203B41FA5}">
                      <a16:colId xmlns:a16="http://schemas.microsoft.com/office/drawing/2014/main" val="1318790665"/>
                    </a:ext>
                  </a:extLst>
                </a:gridCol>
                <a:gridCol w="498266">
                  <a:extLst>
                    <a:ext uri="{9D8B030D-6E8A-4147-A177-3AD203B41FA5}">
                      <a16:colId xmlns:a16="http://schemas.microsoft.com/office/drawing/2014/main" val="3596152961"/>
                    </a:ext>
                  </a:extLst>
                </a:gridCol>
                <a:gridCol w="501180">
                  <a:extLst>
                    <a:ext uri="{9D8B030D-6E8A-4147-A177-3AD203B41FA5}">
                      <a16:colId xmlns:a16="http://schemas.microsoft.com/office/drawing/2014/main" val="1426322467"/>
                    </a:ext>
                  </a:extLst>
                </a:gridCol>
                <a:gridCol w="571113">
                  <a:extLst>
                    <a:ext uri="{9D8B030D-6E8A-4147-A177-3AD203B41FA5}">
                      <a16:colId xmlns:a16="http://schemas.microsoft.com/office/drawing/2014/main" val="3222706216"/>
                    </a:ext>
                  </a:extLst>
                </a:gridCol>
                <a:gridCol w="571113">
                  <a:extLst>
                    <a:ext uri="{9D8B030D-6E8A-4147-A177-3AD203B41FA5}">
                      <a16:colId xmlns:a16="http://schemas.microsoft.com/office/drawing/2014/main" val="3647555816"/>
                    </a:ext>
                  </a:extLst>
                </a:gridCol>
                <a:gridCol w="571113">
                  <a:extLst>
                    <a:ext uri="{9D8B030D-6E8A-4147-A177-3AD203B41FA5}">
                      <a16:colId xmlns:a16="http://schemas.microsoft.com/office/drawing/2014/main" val="171956609"/>
                    </a:ext>
                  </a:extLst>
                </a:gridCol>
                <a:gridCol w="1669631">
                  <a:extLst>
                    <a:ext uri="{9D8B030D-6E8A-4147-A177-3AD203B41FA5}">
                      <a16:colId xmlns:a16="http://schemas.microsoft.com/office/drawing/2014/main" val="1172022154"/>
                    </a:ext>
                  </a:extLst>
                </a:gridCol>
                <a:gridCol w="571113">
                  <a:extLst>
                    <a:ext uri="{9D8B030D-6E8A-4147-A177-3AD203B41FA5}">
                      <a16:colId xmlns:a16="http://schemas.microsoft.com/office/drawing/2014/main" val="3476156214"/>
                    </a:ext>
                  </a:extLst>
                </a:gridCol>
                <a:gridCol w="830444">
                  <a:extLst>
                    <a:ext uri="{9D8B030D-6E8A-4147-A177-3AD203B41FA5}">
                      <a16:colId xmlns:a16="http://schemas.microsoft.com/office/drawing/2014/main" val="4267529432"/>
                    </a:ext>
                  </a:extLst>
                </a:gridCol>
              </a:tblGrid>
              <a:tr h="270522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" sz="1000" u="none" strike="noStrike">
                          <a:effectLst/>
                        </a:rPr>
                        <a:t>Scopus (Embase)</a:t>
                      </a:r>
                      <a:endParaRPr lang="e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6410285"/>
                  </a:ext>
                </a:extLst>
              </a:tr>
              <a:tr h="27052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</a:rPr>
                        <a:t>#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000" u="none" strike="noStrike">
                          <a:effectLst/>
                        </a:rPr>
                        <a:t>literature search formula </a:t>
                      </a:r>
                      <a:endParaRPr lang="e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1000" u="none" strike="noStrike">
                          <a:effectLst/>
                        </a:rPr>
                        <a:t>number of references</a:t>
                      </a:r>
                      <a:endParaRPr lang="en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34304888"/>
                  </a:ext>
                </a:extLst>
              </a:tr>
              <a:tr h="8115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000" u="none" strike="noStrike">
                          <a:effectLst/>
                        </a:rPr>
                        <a:t>( TITLE-ABS ( osteoporosis )  OR  TITLE-ABS ( fracture ) )  AND  ( TITLE-ABS ( glucocorticoid-induced )  OR  TITLE-ABS ( steroid-induced ) )  OR  TITLE-ABS ( giop )  AND  PUBYEAR  &gt;  1999  AND  ( EXCLUDE ( DOCTYPE ,  "er" )  OR  EXCLUDE ( DOCTYPE ,  "tb" ) )  AND  ( LIMIT-TO ( LANGUAGE ,  "English" )  OR  LIMIT-TO ( LANGUAGE ,  "Japanese" ) ) </a:t>
                      </a:r>
                      <a:endParaRPr lang="en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</a:rPr>
                        <a:t>1,426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1091764"/>
                  </a:ext>
                </a:extLst>
              </a:tr>
              <a:tr h="189365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</a:rPr>
                        <a:t>2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000" u="none" strike="noStrike">
                          <a:effectLst/>
                        </a:rPr>
                        <a:t>(TITLE-ABS ( Vitamin D )  OR  TITLE-ABS ( Alfacalcidol )   OR  TITLE-ABS ( Calcitriol )   OR  TITLE-ABS ( Eldecalcitol ) OR TITLE-ABS ( bisphosphonate )  OR  TITLE-ABS ( Alendronate )   OR  TITLE-ABS ( Ibandronate )  OR  TITLE-ABS ( Risedronate )   OR  TITLE-ABS ( Zoledronate ) OR TITLE-ABS ( Selective estrogen receptor modulator )  OR  TITLE-ABS ( SERM )   OR  TITLE-ABS ( Raloxifene )  OR  TITLE-ABS ( Bazedoxifene ) OR TITLE-ABS ( PTH )  OR  TITLE-ABS ( Parathyroid )   OR  TITLE-ABS ( Teriparatide ) OR TITLE-ABS ( RANKL )  OR  TITLE-ABS ( Denosumab ) OR  TITLE-ABS ( Sclerostin )  OR  TITLE-ABS ( Romosozumab ) ) AND  PUBYEAR  &gt;  1999  AND  ( EXCLUDE ( DOCTYPE ,  "er" )  OR  EXCLUDE ( DOCTYPE ,  "tb" ) )  AND  ( LIMIT-TO ( LANGUAGE ,  "English" )  OR  LIMIT-TO ( LANGUAGE ,  "Japanese" ) )</a:t>
                      </a:r>
                      <a:endParaRPr lang="en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</a:rPr>
                        <a:t>132,02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9131081"/>
                  </a:ext>
                </a:extLst>
              </a:tr>
              <a:tr h="13526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</a:rPr>
                        <a:t>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1000" u="none" strike="noStrike">
                          <a:effectLst/>
                        </a:rPr>
                        <a:t>#1 AND #2</a:t>
                      </a:r>
                      <a:endParaRPr lang="en" sz="1000" b="0" i="0" u="none" strike="noStrike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</a:rPr>
                        <a:t>65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 Medium" panose="020B0400000000000000" pitchFamily="34" charset="-128"/>
                        <a:ea typeface="游ゴシック Medium" panose="020B0400000000000000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81480736"/>
                  </a:ext>
                </a:extLst>
              </a:tr>
            </a:tbl>
          </a:graphicData>
        </a:graphic>
      </p:graphicFrame>
      <p:pic>
        <p:nvPicPr>
          <p:cNvPr id="8" name="図 7" descr="ダイアグラム&#10;&#10;自動的に生成された説明">
            <a:extLst>
              <a:ext uri="{FF2B5EF4-FFF2-40B4-BE49-F238E27FC236}">
                <a16:creationId xmlns:a16="http://schemas.microsoft.com/office/drawing/2014/main" id="{97997BAC-F45D-E4C5-850B-4F3B8D6412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28856" y="90609"/>
            <a:ext cx="4621378" cy="63029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337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2032</Words>
  <Application>Microsoft Macintosh PowerPoint</Application>
  <PresentationFormat>ワイド画面</PresentationFormat>
  <Paragraphs>188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3" baseType="lpstr">
      <vt:lpstr>游ゴシック</vt:lpstr>
      <vt:lpstr>游ゴシック Light</vt:lpstr>
      <vt:lpstr>游ゴシック Medium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良哉 田中</dc:creator>
  <cp:lastModifiedBy>良哉 田中</cp:lastModifiedBy>
  <cp:revision>10</cp:revision>
  <dcterms:created xsi:type="dcterms:W3CDTF">2024-01-27T06:04:09Z</dcterms:created>
  <dcterms:modified xsi:type="dcterms:W3CDTF">2024-01-27T08:17:36Z</dcterms:modified>
</cp:coreProperties>
</file>